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  <p:sldId id="260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1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CC2D-3270-440D-8EBE-965894B86043}" type="datetimeFigureOut">
              <a:rPr lang="en-US" smtClean="0"/>
              <a:t>6/2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87B6A-035B-4E65-BAC0-B187C9ED4C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6187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CC2D-3270-440D-8EBE-965894B86043}" type="datetimeFigureOut">
              <a:rPr lang="en-US" smtClean="0"/>
              <a:t>6/2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87B6A-035B-4E65-BAC0-B187C9ED4C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27808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CC2D-3270-440D-8EBE-965894B86043}" type="datetimeFigureOut">
              <a:rPr lang="en-US" smtClean="0"/>
              <a:t>6/2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87B6A-035B-4E65-BAC0-B187C9ED4C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68894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CC2D-3270-440D-8EBE-965894B86043}" type="datetimeFigureOut">
              <a:rPr lang="en-US" smtClean="0"/>
              <a:t>6/2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87B6A-035B-4E65-BAC0-B187C9ED4C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53820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CC2D-3270-440D-8EBE-965894B86043}" type="datetimeFigureOut">
              <a:rPr lang="en-US" smtClean="0"/>
              <a:t>6/2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87B6A-035B-4E65-BAC0-B187C9ED4C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97435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CC2D-3270-440D-8EBE-965894B86043}" type="datetimeFigureOut">
              <a:rPr lang="en-US" smtClean="0"/>
              <a:t>6/2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87B6A-035B-4E65-BAC0-B187C9ED4C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60890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CC2D-3270-440D-8EBE-965894B86043}" type="datetimeFigureOut">
              <a:rPr lang="en-US" smtClean="0"/>
              <a:t>6/28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87B6A-035B-4E65-BAC0-B187C9ED4C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03589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CC2D-3270-440D-8EBE-965894B86043}" type="datetimeFigureOut">
              <a:rPr lang="en-US" smtClean="0"/>
              <a:t>6/28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87B6A-035B-4E65-BAC0-B187C9ED4C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95412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CC2D-3270-440D-8EBE-965894B86043}" type="datetimeFigureOut">
              <a:rPr lang="en-US" smtClean="0"/>
              <a:t>6/28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87B6A-035B-4E65-BAC0-B187C9ED4C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4693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CC2D-3270-440D-8EBE-965894B86043}" type="datetimeFigureOut">
              <a:rPr lang="en-US" smtClean="0"/>
              <a:t>6/2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87B6A-035B-4E65-BAC0-B187C9ED4C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23483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CC2D-3270-440D-8EBE-965894B86043}" type="datetimeFigureOut">
              <a:rPr lang="en-US" smtClean="0"/>
              <a:t>6/2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87B6A-035B-4E65-BAC0-B187C9ED4C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88015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06CC2D-3270-440D-8EBE-965894B86043}" type="datetimeFigureOut">
              <a:rPr lang="en-US" smtClean="0"/>
              <a:t>6/2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B87B6A-035B-4E65-BAC0-B187C9ED4C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39986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4236332461"/>
              </p:ext>
            </p:extLst>
          </p:nvPr>
        </p:nvGraphicFramePr>
        <p:xfrm>
          <a:off x="2598665" y="1922927"/>
          <a:ext cx="7244581" cy="1768401"/>
        </p:xfrm>
        <a:graphic>
          <a:graphicData uri="http://schemas.openxmlformats.org/drawingml/2006/table">
            <a:tbl>
              <a:tblPr firstRow="1" firstCol="1" bandRow="1"/>
              <a:tblGrid>
                <a:gridCol w="1695633">
                  <a:extLst>
                    <a:ext uri="{9D8B030D-6E8A-4147-A177-3AD203B41FA5}">
                      <a16:colId xmlns:a16="http://schemas.microsoft.com/office/drawing/2014/main" val="3666575322"/>
                    </a:ext>
                  </a:extLst>
                </a:gridCol>
                <a:gridCol w="1064600">
                  <a:extLst>
                    <a:ext uri="{9D8B030D-6E8A-4147-A177-3AD203B41FA5}">
                      <a16:colId xmlns:a16="http://schemas.microsoft.com/office/drawing/2014/main" val="1459901276"/>
                    </a:ext>
                  </a:extLst>
                </a:gridCol>
                <a:gridCol w="1143300">
                  <a:extLst>
                    <a:ext uri="{9D8B030D-6E8A-4147-A177-3AD203B41FA5}">
                      <a16:colId xmlns:a16="http://schemas.microsoft.com/office/drawing/2014/main" val="2566583265"/>
                    </a:ext>
                  </a:extLst>
                </a:gridCol>
                <a:gridCol w="304648">
                  <a:extLst>
                    <a:ext uri="{9D8B030D-6E8A-4147-A177-3AD203B41FA5}">
                      <a16:colId xmlns:a16="http://schemas.microsoft.com/office/drawing/2014/main" val="1653665183"/>
                    </a:ext>
                  </a:extLst>
                </a:gridCol>
                <a:gridCol w="1064600">
                  <a:extLst>
                    <a:ext uri="{9D8B030D-6E8A-4147-A177-3AD203B41FA5}">
                      <a16:colId xmlns:a16="http://schemas.microsoft.com/office/drawing/2014/main" val="3419941543"/>
                    </a:ext>
                  </a:extLst>
                </a:gridCol>
                <a:gridCol w="985900">
                  <a:extLst>
                    <a:ext uri="{9D8B030D-6E8A-4147-A177-3AD203B41FA5}">
                      <a16:colId xmlns:a16="http://schemas.microsoft.com/office/drawing/2014/main" val="2150674593"/>
                    </a:ext>
                  </a:extLst>
                </a:gridCol>
                <a:gridCol w="985900">
                  <a:extLst>
                    <a:ext uri="{9D8B030D-6E8A-4147-A177-3AD203B41FA5}">
                      <a16:colId xmlns:a16="http://schemas.microsoft.com/office/drawing/2014/main" val="3766934127"/>
                    </a:ext>
                  </a:extLst>
                </a:gridCol>
              </a:tblGrid>
              <a:tr h="51355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cho Parameter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 smtClea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ontrol (</a:t>
                      </a:r>
                      <a:r>
                        <a:rPr lang="en-US" sz="1100" b="1" dirty="0" err="1" smtClea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tl</a:t>
                      </a:r>
                      <a:r>
                        <a:rPr lang="en-US" sz="1100" b="1" dirty="0" smtClea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) </a:t>
                      </a: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[Baseline]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IV-Transgenic (Tg) [Baseline]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tl</a:t>
                      </a:r>
                      <a:r>
                        <a:rPr lang="en-US" sz="11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[6 </a:t>
                      </a:r>
                      <a:r>
                        <a:rPr lang="en-US" sz="1100" b="1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Wks</a:t>
                      </a:r>
                      <a:r>
                        <a:rPr lang="en-US" sz="11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]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tl [12 Wks]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tl [18 Wks]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57134848"/>
                  </a:ext>
                </a:extLst>
              </a:tr>
              <a:tr h="250969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LVEF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852±0.00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8325±0.00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844±0.00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844±0.00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874±0.0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88468596"/>
                  </a:ext>
                </a:extLst>
              </a:tr>
              <a:tr h="250969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%FS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7.11±0.79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5.11±0.7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6.342±0.9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6.312±0.8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9.872±1.3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13623797"/>
                  </a:ext>
                </a:extLst>
              </a:tr>
              <a:tr h="250969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Mitral Valve E/A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943±0.33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938±1.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.006±0.19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91±0.2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.176±0.2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64952513"/>
                  </a:ext>
                </a:extLst>
              </a:tr>
              <a:tr h="250969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ortic </a:t>
                      </a:r>
                      <a:r>
                        <a:rPr lang="en-US" sz="1100" b="1" dirty="0" err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max</a:t>
                      </a: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[mmHg]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.665±0.23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.64±0.1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.03±0.40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.212±0.13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.09±0.3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82174928"/>
                  </a:ext>
                </a:extLst>
              </a:tr>
              <a:tr h="250969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rdiac Output [L/min]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0733±0.003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07±0.002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078±0.0048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076±0.005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072±0.003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39765065"/>
                  </a:ext>
                </a:extLst>
              </a:tr>
            </a:tbl>
          </a:graphicData>
        </a:graphic>
      </p:graphicFrame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07613531"/>
              </p:ext>
            </p:extLst>
          </p:nvPr>
        </p:nvGraphicFramePr>
        <p:xfrm>
          <a:off x="2597452" y="3724834"/>
          <a:ext cx="7259241" cy="939660"/>
        </p:xfrm>
        <a:graphic>
          <a:graphicData uri="http://schemas.openxmlformats.org/drawingml/2006/table">
            <a:tbl>
              <a:tblPr firstRow="1" firstCol="1" bandRow="1"/>
              <a:tblGrid>
                <a:gridCol w="1702722">
                  <a:extLst>
                    <a:ext uri="{9D8B030D-6E8A-4147-A177-3AD203B41FA5}">
                      <a16:colId xmlns:a16="http://schemas.microsoft.com/office/drawing/2014/main" val="2505407202"/>
                    </a:ext>
                  </a:extLst>
                </a:gridCol>
                <a:gridCol w="1062768">
                  <a:extLst>
                    <a:ext uri="{9D8B030D-6E8A-4147-A177-3AD203B41FA5}">
                      <a16:colId xmlns:a16="http://schemas.microsoft.com/office/drawing/2014/main" val="2887230330"/>
                    </a:ext>
                  </a:extLst>
                </a:gridCol>
                <a:gridCol w="1145181">
                  <a:extLst>
                    <a:ext uri="{9D8B030D-6E8A-4147-A177-3AD203B41FA5}">
                      <a16:colId xmlns:a16="http://schemas.microsoft.com/office/drawing/2014/main" val="153331203"/>
                    </a:ext>
                  </a:extLst>
                </a:gridCol>
                <a:gridCol w="305026">
                  <a:extLst>
                    <a:ext uri="{9D8B030D-6E8A-4147-A177-3AD203B41FA5}">
                      <a16:colId xmlns:a16="http://schemas.microsoft.com/office/drawing/2014/main" val="1525873617"/>
                    </a:ext>
                  </a:extLst>
                </a:gridCol>
                <a:gridCol w="1062768">
                  <a:extLst>
                    <a:ext uri="{9D8B030D-6E8A-4147-A177-3AD203B41FA5}">
                      <a16:colId xmlns:a16="http://schemas.microsoft.com/office/drawing/2014/main" val="2944725911"/>
                    </a:ext>
                  </a:extLst>
                </a:gridCol>
                <a:gridCol w="990388">
                  <a:extLst>
                    <a:ext uri="{9D8B030D-6E8A-4147-A177-3AD203B41FA5}">
                      <a16:colId xmlns:a16="http://schemas.microsoft.com/office/drawing/2014/main" val="1116564142"/>
                    </a:ext>
                  </a:extLst>
                </a:gridCol>
                <a:gridCol w="990388">
                  <a:extLst>
                    <a:ext uri="{9D8B030D-6E8A-4147-A177-3AD203B41FA5}">
                      <a16:colId xmlns:a16="http://schemas.microsoft.com/office/drawing/2014/main" val="2712992668"/>
                    </a:ext>
                  </a:extLst>
                </a:gridCol>
              </a:tblGrid>
              <a:tr h="23491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baseline="0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IVSd</a:t>
                      </a:r>
                      <a:r>
                        <a:rPr lang="en-US" sz="1100" b="1" baseline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[mm]</a:t>
                      </a:r>
                      <a:endParaRPr lang="en-US" sz="1100" baseline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aseline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37±0.066</a:t>
                      </a:r>
                      <a:endParaRPr lang="en-US" sz="1100" baseline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aseline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224±0.04</a:t>
                      </a:r>
                      <a:endParaRPr lang="en-US" sz="1100" baseline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aseline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aseline="0" dirty="0">
                          <a:solidFill>
                            <a:schemeClr val="tx1"/>
                          </a:solidFill>
                          <a:effectLst/>
                          <a:latin typeface="Symbol" panose="05050102010706020507" pitchFamily="18" charset="2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434±0.042</a:t>
                      </a:r>
                      <a:endParaRPr lang="en-US" sz="1100" baseline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aseline="0">
                          <a:solidFill>
                            <a:schemeClr val="tx1"/>
                          </a:solidFill>
                          <a:effectLst/>
                          <a:latin typeface="Symbol" panose="05050102010706020507" pitchFamily="18" charset="2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522±0.12</a:t>
                      </a:r>
                      <a:endParaRPr lang="en-US" sz="1100" baseline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aseline="0" dirty="0">
                          <a:solidFill>
                            <a:schemeClr val="tx1"/>
                          </a:solidFill>
                          <a:effectLst/>
                          <a:latin typeface="Symbol" panose="05050102010706020507" pitchFamily="18" charset="2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35±0.069</a:t>
                      </a:r>
                      <a:endParaRPr lang="en-US" sz="1100" baseline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84549689"/>
                  </a:ext>
                </a:extLst>
              </a:tr>
              <a:tr h="23491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baseline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IVSs [mm]</a:t>
                      </a:r>
                      <a:endParaRPr lang="en-US" sz="1100" baseline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aseline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.238±0.077</a:t>
                      </a:r>
                      <a:endParaRPr lang="en-US" sz="1100" baseline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aseline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.236±0.13</a:t>
                      </a:r>
                      <a:endParaRPr lang="en-US" sz="1100" baseline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aseline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aseline="0">
                          <a:solidFill>
                            <a:schemeClr val="tx1"/>
                          </a:solidFill>
                          <a:effectLst/>
                          <a:latin typeface="Symbol" panose="05050102010706020507" pitchFamily="18" charset="2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.636±0.11</a:t>
                      </a:r>
                      <a:endParaRPr lang="en-US" sz="1100" baseline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aseline="0">
                          <a:solidFill>
                            <a:schemeClr val="tx1"/>
                          </a:solidFill>
                          <a:effectLst/>
                          <a:latin typeface="Symbol" panose="05050102010706020507" pitchFamily="18" charset="2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.576±0.11</a:t>
                      </a:r>
                      <a:endParaRPr lang="en-US" sz="1100" baseline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aseline="0">
                          <a:solidFill>
                            <a:schemeClr val="tx1"/>
                          </a:solidFill>
                          <a:effectLst/>
                          <a:latin typeface="Symbol" panose="05050102010706020507" pitchFamily="18" charset="2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.722±0.089</a:t>
                      </a:r>
                      <a:endParaRPr lang="en-US" sz="1100" baseline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67344172"/>
                  </a:ext>
                </a:extLst>
              </a:tr>
              <a:tr h="23491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baseline="0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LVPWd</a:t>
                      </a:r>
                      <a:r>
                        <a:rPr lang="en-US" sz="1100" b="1" baseline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[mm]</a:t>
                      </a:r>
                      <a:endParaRPr lang="en-US" sz="1100" baseline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aseline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518±0.12</a:t>
                      </a:r>
                      <a:endParaRPr lang="en-US" sz="1100" baseline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aseline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394±0.077</a:t>
                      </a:r>
                      <a:endParaRPr lang="en-US" sz="1100" baseline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aseline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aseline="0">
                          <a:solidFill>
                            <a:schemeClr val="tx1"/>
                          </a:solidFill>
                          <a:effectLst/>
                          <a:latin typeface="Symbol" panose="05050102010706020507" pitchFamily="18" charset="2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562±0.078</a:t>
                      </a:r>
                      <a:endParaRPr lang="en-US" sz="1100" baseline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aseline="0">
                          <a:solidFill>
                            <a:schemeClr val="tx1"/>
                          </a:solidFill>
                          <a:effectLst/>
                          <a:latin typeface="Symbol" panose="05050102010706020507" pitchFamily="18" charset="2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434±0.11</a:t>
                      </a:r>
                      <a:endParaRPr lang="en-US" sz="1100" baseline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aseline="0">
                          <a:solidFill>
                            <a:schemeClr val="tx1"/>
                          </a:solidFill>
                          <a:effectLst/>
                          <a:latin typeface="Symbol" panose="05050102010706020507" pitchFamily="18" charset="2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434±0.1</a:t>
                      </a:r>
                      <a:endParaRPr lang="en-US" sz="1100" baseline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45900138"/>
                  </a:ext>
                </a:extLst>
              </a:tr>
              <a:tr h="23491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baseline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LVPWs [mm]</a:t>
                      </a:r>
                      <a:endParaRPr lang="en-US" sz="1100" baseline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aseline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.554±0.1</a:t>
                      </a:r>
                      <a:endParaRPr lang="en-US" sz="1100" baseline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baseline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.375±0.108</a:t>
                      </a:r>
                      <a:endParaRPr lang="en-US" sz="1100" b="0" baseline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aseline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aseline="0" dirty="0">
                          <a:solidFill>
                            <a:schemeClr val="tx1"/>
                          </a:solidFill>
                          <a:effectLst/>
                          <a:latin typeface="Symbol" panose="05050102010706020507" pitchFamily="18" charset="2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.236±0.098</a:t>
                      </a:r>
                      <a:endParaRPr lang="en-US" sz="1100" baseline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aseline="0" dirty="0">
                          <a:solidFill>
                            <a:schemeClr val="tx1"/>
                          </a:solidFill>
                          <a:effectLst/>
                          <a:latin typeface="Symbol" panose="05050102010706020507" pitchFamily="18" charset="2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.428±0.07</a:t>
                      </a:r>
                      <a:endParaRPr lang="en-US" sz="1100" baseline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aseline="0" dirty="0">
                          <a:solidFill>
                            <a:schemeClr val="tx1"/>
                          </a:solidFill>
                          <a:effectLst/>
                          <a:latin typeface="Symbol" panose="05050102010706020507" pitchFamily="18" charset="2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.576±0.06</a:t>
                      </a:r>
                      <a:endParaRPr lang="en-US" sz="1100" baseline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78963420"/>
                  </a:ext>
                </a:extLst>
              </a:tr>
            </a:tbl>
          </a:graphicData>
        </a:graphic>
      </p:graphicFrame>
      <p:sp>
        <p:nvSpPr>
          <p:cNvPr id="4" name="Text Box 1"/>
          <p:cNvSpPr txBox="1">
            <a:spLocks noChangeAspect="1"/>
          </p:cNvSpPr>
          <p:nvPr/>
        </p:nvSpPr>
        <p:spPr>
          <a:xfrm>
            <a:off x="2489203" y="1416128"/>
            <a:ext cx="7313702" cy="429260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marL="0" marR="0" algn="just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100" b="1" dirty="0" smtClean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able S1. </a:t>
            </a:r>
            <a:r>
              <a:rPr lang="en-US" sz="11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chocardiography parameters for control and HIV-transgenic rats at baseline, and time-matched controls at 6, 12 and 18 weeks.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" name="Rectangle 4"/>
          <p:cNvSpPr>
            <a:spLocks noChangeAspect="1" noChangeArrowheads="1"/>
          </p:cNvSpPr>
          <p:nvPr/>
        </p:nvSpPr>
        <p:spPr bwMode="auto">
          <a:xfrm>
            <a:off x="2581909" y="4659389"/>
            <a:ext cx="7342019" cy="12323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  <a:noAutofit/>
          </a:bodyPr>
          <a:lstStyle/>
          <a:p>
            <a:r>
              <a:rPr lang="en-US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rior to any treatment, non-invasive echocardiography was performed once age-matched control </a:t>
            </a:r>
            <a:r>
              <a:rPr lang="en-US" sz="1100" kern="1200" dirty="0" smtClean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(Fischer 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344) and Tg rats reached age 3 months (baseline).  </a:t>
            </a:r>
            <a:r>
              <a:rPr lang="en-US" sz="1100" kern="1200" dirty="0" smtClean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Control (</a:t>
            </a:r>
            <a:r>
              <a:rPr lang="en-US" sz="1100" kern="1200" dirty="0" err="1" smtClean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Ctl</a:t>
            </a:r>
            <a:r>
              <a:rPr lang="en-US" sz="1100" kern="1200" dirty="0" smtClean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) rats 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were on normal magnesium </a:t>
            </a:r>
            <a:r>
              <a:rPr lang="en-US" sz="1100" kern="1200" dirty="0" smtClean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diet for 6, 12 and 18 weeks. 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No values for </a:t>
            </a:r>
            <a:r>
              <a:rPr lang="en-US" sz="1100" kern="1200" dirty="0" smtClean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baseline Tg 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were significantly different </a:t>
            </a:r>
            <a:r>
              <a:rPr lang="en-US" sz="1100" kern="1200" dirty="0" smtClean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rom baseline 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control.  </a:t>
            </a:r>
            <a:r>
              <a:rPr lang="en-US" sz="11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LVEF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= left ventricular ejection fraction; </a:t>
            </a:r>
            <a:r>
              <a:rPr lang="en-US" sz="11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%FS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= % fractional shortening; </a:t>
            </a:r>
            <a:r>
              <a:rPr lang="en-US" sz="11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Mitral Valve E/A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= mitral valve E/A ratio; </a:t>
            </a:r>
            <a:r>
              <a:rPr lang="en-US" sz="11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ortic </a:t>
            </a:r>
            <a:r>
              <a:rPr lang="en-US" sz="1100" b="1" kern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max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= Aortic pressure maximum (mmHg); and </a:t>
            </a:r>
            <a:r>
              <a:rPr lang="en-US" sz="11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CO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= cardiac output (L/min</a:t>
            </a:r>
            <a:r>
              <a:rPr lang="en-US" sz="1100" kern="1200" dirty="0" smtClean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);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IVSd &amp; s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= interventricular septum dimension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mm) in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iastole and systole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; </a:t>
            </a:r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LVPWd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&amp; s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= left ventricular posterior wall dimension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mm) in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iastole and systole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sz="1100" kern="1200" dirty="0" smtClean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Values are means ± SE of 5 rats/group.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229424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8" name="Group 27"/>
          <p:cNvGrpSpPr/>
          <p:nvPr/>
        </p:nvGrpSpPr>
        <p:grpSpPr>
          <a:xfrm>
            <a:off x="3578802" y="1149111"/>
            <a:ext cx="5007926" cy="3425755"/>
            <a:chOff x="2377531" y="1418052"/>
            <a:chExt cx="5007926" cy="3425755"/>
          </a:xfrm>
        </p:grpSpPr>
        <p:grpSp>
          <p:nvGrpSpPr>
            <p:cNvPr id="27" name="Group 26"/>
            <p:cNvGrpSpPr/>
            <p:nvPr/>
          </p:nvGrpSpPr>
          <p:grpSpPr>
            <a:xfrm>
              <a:off x="4990890" y="1418052"/>
              <a:ext cx="2394567" cy="3425755"/>
              <a:chOff x="4990890" y="1418052"/>
              <a:chExt cx="2394567" cy="3425755"/>
            </a:xfrm>
          </p:grpSpPr>
          <p:grpSp>
            <p:nvGrpSpPr>
              <p:cNvPr id="25" name="Group 24"/>
              <p:cNvGrpSpPr/>
              <p:nvPr/>
            </p:nvGrpSpPr>
            <p:grpSpPr>
              <a:xfrm>
                <a:off x="4990890" y="1418052"/>
                <a:ext cx="2394567" cy="1637486"/>
                <a:chOff x="5167102" y="1056102"/>
                <a:chExt cx="2394567" cy="1637486"/>
              </a:xfrm>
            </p:grpSpPr>
            <p:pic>
              <p:nvPicPr>
                <p:cNvPr id="6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810" t="15688" r="3514" b="4614"/>
                <a:stretch/>
              </p:blipFill>
              <p:spPr bwMode="auto">
                <a:xfrm>
                  <a:off x="5167102" y="1056102"/>
                  <a:ext cx="2394567" cy="163748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14" name="TextBox 13"/>
                <p:cNvSpPr txBox="1"/>
                <p:nvPr/>
              </p:nvSpPr>
              <p:spPr>
                <a:xfrm>
                  <a:off x="5801906" y="1266475"/>
                  <a:ext cx="470642" cy="184666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lIns="0" tIns="0" rIns="91440" bIns="91440" rtlCol="0">
                  <a:spAutoFit/>
                </a:bodyPr>
                <a:lstStyle/>
                <a:p>
                  <a:r>
                    <a:rPr lang="en-US" sz="600" dirty="0" smtClean="0">
                      <a:latin typeface="Arial" panose="020B0604020202020204" pitchFamily="34" charset="0"/>
                    </a:rPr>
                    <a:t>Mg Normal</a:t>
                  </a:r>
                  <a:endParaRPr lang="en-US" sz="600" dirty="0"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7" name="TextBox 16"/>
                <p:cNvSpPr txBox="1"/>
                <p:nvPr/>
              </p:nvSpPr>
              <p:spPr>
                <a:xfrm>
                  <a:off x="6822986" y="1262665"/>
                  <a:ext cx="419346" cy="184666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lIns="0" tIns="0" rIns="91440" bIns="91440" rtlCol="0">
                  <a:spAutoFit/>
                </a:bodyPr>
                <a:lstStyle/>
                <a:p>
                  <a:r>
                    <a:rPr lang="en-US" sz="600" dirty="0" smtClean="0">
                      <a:latin typeface="Arial" panose="020B0604020202020204" pitchFamily="34" charset="0"/>
                    </a:rPr>
                    <a:t>Mg </a:t>
                  </a:r>
                  <a:r>
                    <a:rPr lang="en-US" sz="600" dirty="0" err="1" smtClean="0">
                      <a:latin typeface="Arial" panose="020B0604020202020204" pitchFamily="34" charset="0"/>
                    </a:rPr>
                    <a:t>Suppl</a:t>
                  </a:r>
                  <a:endParaRPr lang="en-US" sz="600" dirty="0">
                    <a:latin typeface="Arial" panose="020B0604020202020204" pitchFamily="34" charset="0"/>
                  </a:endParaRPr>
                </a:p>
              </p:txBody>
            </p:sp>
          </p:grpSp>
          <p:grpSp>
            <p:nvGrpSpPr>
              <p:cNvPr id="26" name="Group 25"/>
              <p:cNvGrpSpPr/>
              <p:nvPr/>
            </p:nvGrpSpPr>
            <p:grpSpPr>
              <a:xfrm>
                <a:off x="4998677" y="3206321"/>
                <a:ext cx="2360640" cy="1637486"/>
                <a:chOff x="5170127" y="3225371"/>
                <a:chExt cx="2360640" cy="1637486"/>
              </a:xfrm>
            </p:grpSpPr>
            <p:pic>
              <p:nvPicPr>
                <p:cNvPr id="12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606" t="15909" r="3869" b="3382"/>
                <a:stretch/>
              </p:blipFill>
              <p:spPr bwMode="auto">
                <a:xfrm>
                  <a:off x="5170127" y="3225371"/>
                  <a:ext cx="2360640" cy="163748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16" name="TextBox 15"/>
                <p:cNvSpPr txBox="1"/>
                <p:nvPr/>
              </p:nvSpPr>
              <p:spPr>
                <a:xfrm>
                  <a:off x="5786666" y="3419125"/>
                  <a:ext cx="470642" cy="184666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lIns="0" tIns="0" rIns="91440" bIns="91440" rtlCol="0">
                  <a:spAutoFit/>
                </a:bodyPr>
                <a:lstStyle/>
                <a:p>
                  <a:r>
                    <a:rPr lang="en-US" sz="600" dirty="0" smtClean="0">
                      <a:latin typeface="Arial" panose="020B0604020202020204" pitchFamily="34" charset="0"/>
                    </a:rPr>
                    <a:t>Mg Normal</a:t>
                  </a:r>
                  <a:endParaRPr lang="en-US" sz="600" dirty="0"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9" name="TextBox 18"/>
                <p:cNvSpPr txBox="1"/>
                <p:nvPr/>
              </p:nvSpPr>
              <p:spPr>
                <a:xfrm>
                  <a:off x="6813461" y="3426745"/>
                  <a:ext cx="419346" cy="184666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lIns="0" tIns="0" rIns="91440" bIns="91440" rtlCol="0">
                  <a:spAutoFit/>
                </a:bodyPr>
                <a:lstStyle/>
                <a:p>
                  <a:r>
                    <a:rPr lang="en-US" sz="600" dirty="0" smtClean="0">
                      <a:latin typeface="Arial" panose="020B0604020202020204" pitchFamily="34" charset="0"/>
                    </a:rPr>
                    <a:t>Mg </a:t>
                  </a:r>
                  <a:r>
                    <a:rPr lang="en-US" sz="600" dirty="0" err="1" smtClean="0">
                      <a:latin typeface="Arial" panose="020B0604020202020204" pitchFamily="34" charset="0"/>
                    </a:rPr>
                    <a:t>Suppl</a:t>
                  </a:r>
                  <a:endParaRPr lang="en-US" sz="600" dirty="0">
                    <a:latin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24" name="Group 23"/>
            <p:cNvGrpSpPr/>
            <p:nvPr/>
          </p:nvGrpSpPr>
          <p:grpSpPr>
            <a:xfrm>
              <a:off x="2377531" y="1421456"/>
              <a:ext cx="2427428" cy="3410915"/>
              <a:chOff x="2377531" y="1421456"/>
              <a:chExt cx="2427428" cy="3410915"/>
            </a:xfrm>
          </p:grpSpPr>
          <p:grpSp>
            <p:nvGrpSpPr>
              <p:cNvPr id="23" name="Group 22"/>
              <p:cNvGrpSpPr/>
              <p:nvPr/>
            </p:nvGrpSpPr>
            <p:grpSpPr>
              <a:xfrm>
                <a:off x="2403542" y="1421456"/>
                <a:ext cx="2349032" cy="1637486"/>
                <a:chOff x="2422592" y="1121419"/>
                <a:chExt cx="2349032" cy="1637486"/>
              </a:xfrm>
            </p:grpSpPr>
            <p:grpSp>
              <p:nvGrpSpPr>
                <p:cNvPr id="2" name="Group 1"/>
                <p:cNvGrpSpPr>
                  <a:grpSpLocks noChangeAspect="1"/>
                </p:cNvGrpSpPr>
                <p:nvPr/>
              </p:nvGrpSpPr>
              <p:grpSpPr>
                <a:xfrm>
                  <a:off x="2422592" y="1121419"/>
                  <a:ext cx="2349032" cy="1637486"/>
                  <a:chOff x="2072395" y="1131146"/>
                  <a:chExt cx="6711518" cy="4678532"/>
                </a:xfrm>
              </p:grpSpPr>
              <p:pic>
                <p:nvPicPr>
                  <p:cNvPr id="3" name="Picture 2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4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6754" t="15767" r="3928" b="3313"/>
                  <a:stretch/>
                </p:blipFill>
                <p:spPr bwMode="auto">
                  <a:xfrm>
                    <a:off x="2072395" y="1131146"/>
                    <a:ext cx="6711518" cy="467853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sp>
                <p:nvSpPr>
                  <p:cNvPr id="4" name="TextBox 3"/>
                  <p:cNvSpPr txBox="1"/>
                  <p:nvPr/>
                </p:nvSpPr>
                <p:spPr>
                  <a:xfrm>
                    <a:off x="3824549" y="1730649"/>
                    <a:ext cx="1344691" cy="527617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lIns="0" tIns="0" rIns="91440" bIns="91440" rtlCol="0">
                    <a:spAutoFit/>
                  </a:bodyPr>
                  <a:lstStyle/>
                  <a:p>
                    <a:r>
                      <a:rPr lang="en-US" sz="600" dirty="0" smtClean="0">
                        <a:latin typeface="Arial" panose="020B0604020202020204" pitchFamily="34" charset="0"/>
                      </a:rPr>
                      <a:t>Mg Normal</a:t>
                    </a:r>
                    <a:endParaRPr lang="en-US" sz="600" dirty="0">
                      <a:latin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18" name="TextBox 17"/>
                <p:cNvSpPr txBox="1"/>
                <p:nvPr/>
              </p:nvSpPr>
              <p:spPr>
                <a:xfrm>
                  <a:off x="4056926" y="1330293"/>
                  <a:ext cx="419346" cy="184666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lIns="0" tIns="0" rIns="91440" bIns="91440" rtlCol="0">
                  <a:spAutoFit/>
                </a:bodyPr>
                <a:lstStyle/>
                <a:p>
                  <a:r>
                    <a:rPr lang="en-US" sz="600" dirty="0" smtClean="0">
                      <a:latin typeface="Arial" panose="020B0604020202020204" pitchFamily="34" charset="0"/>
                    </a:rPr>
                    <a:t>Mg </a:t>
                  </a:r>
                  <a:r>
                    <a:rPr lang="en-US" sz="600" dirty="0" err="1" smtClean="0">
                      <a:latin typeface="Arial" panose="020B0604020202020204" pitchFamily="34" charset="0"/>
                    </a:rPr>
                    <a:t>Suppl</a:t>
                  </a:r>
                  <a:endParaRPr lang="en-US" sz="600" dirty="0">
                    <a:latin typeface="Arial" panose="020B0604020202020204" pitchFamily="34" charset="0"/>
                  </a:endParaRPr>
                </a:p>
              </p:txBody>
            </p:sp>
          </p:grpSp>
          <p:grpSp>
            <p:nvGrpSpPr>
              <p:cNvPr id="22" name="Group 21"/>
              <p:cNvGrpSpPr/>
              <p:nvPr/>
            </p:nvGrpSpPr>
            <p:grpSpPr>
              <a:xfrm>
                <a:off x="2377531" y="3194885"/>
                <a:ext cx="2427428" cy="1637486"/>
                <a:chOff x="2377531" y="3194885"/>
                <a:chExt cx="2427428" cy="1637486"/>
              </a:xfrm>
            </p:grpSpPr>
            <p:pic>
              <p:nvPicPr>
                <p:cNvPr id="9" name="Picture 8"/>
                <p:cNvPicPr>
                  <a:picLocks noChangeAspect="1" noChangeArrowheads="1"/>
                </p:cNvPicPr>
                <p:nvPr/>
              </p:nvPicPr>
              <p:blipFill rotWithShape="1"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547" t="16194" r="3619" b="5048"/>
                <a:stretch/>
              </p:blipFill>
              <p:spPr bwMode="auto">
                <a:xfrm>
                  <a:off x="2377531" y="3194885"/>
                  <a:ext cx="2427428" cy="163748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15" name="TextBox 14"/>
                <p:cNvSpPr txBox="1"/>
                <p:nvPr/>
              </p:nvSpPr>
              <p:spPr>
                <a:xfrm>
                  <a:off x="3013938" y="3403885"/>
                  <a:ext cx="470642" cy="184666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lIns="0" tIns="0" rIns="91440" bIns="91440" rtlCol="0">
                  <a:spAutoFit/>
                </a:bodyPr>
                <a:lstStyle/>
                <a:p>
                  <a:r>
                    <a:rPr lang="en-US" sz="600" dirty="0" smtClean="0">
                      <a:latin typeface="Arial" panose="020B0604020202020204" pitchFamily="34" charset="0"/>
                    </a:rPr>
                    <a:t>Mg Normal</a:t>
                  </a:r>
                  <a:endParaRPr lang="en-US" sz="600" dirty="0"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0" name="TextBox 19"/>
                <p:cNvSpPr txBox="1"/>
                <p:nvPr/>
              </p:nvSpPr>
              <p:spPr>
                <a:xfrm>
                  <a:off x="4060736" y="3405790"/>
                  <a:ext cx="419346" cy="184666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lIns="0" tIns="0" rIns="91440" bIns="91440" rtlCol="0">
                  <a:spAutoFit/>
                </a:bodyPr>
                <a:lstStyle/>
                <a:p>
                  <a:r>
                    <a:rPr lang="en-US" sz="600" dirty="0" smtClean="0">
                      <a:latin typeface="Arial" panose="020B0604020202020204" pitchFamily="34" charset="0"/>
                    </a:rPr>
                    <a:t>Mg </a:t>
                  </a:r>
                  <a:r>
                    <a:rPr lang="en-US" sz="600" dirty="0" err="1" smtClean="0">
                      <a:latin typeface="Arial" panose="020B0604020202020204" pitchFamily="34" charset="0"/>
                    </a:rPr>
                    <a:t>Suppl</a:t>
                  </a:r>
                  <a:endParaRPr lang="en-US" sz="600" dirty="0">
                    <a:latin typeface="Arial" panose="020B0604020202020204" pitchFamily="34" charset="0"/>
                  </a:endParaRPr>
                </a:p>
              </p:txBody>
            </p:sp>
          </p:grpSp>
        </p:grpSp>
      </p:grpSp>
      <p:sp>
        <p:nvSpPr>
          <p:cNvPr id="29" name="Rectangle 28"/>
          <p:cNvSpPr>
            <a:spLocks noChangeAspect="1" noChangeArrowheads="1"/>
          </p:cNvSpPr>
          <p:nvPr/>
        </p:nvSpPr>
        <p:spPr bwMode="auto">
          <a:xfrm>
            <a:off x="2544855" y="4826730"/>
            <a:ext cx="7342019" cy="10124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  <a:noAutofit/>
          </a:bodyPr>
          <a:lstStyle/>
          <a:p>
            <a:r>
              <a:rPr lang="en-US" sz="1100" b="1" kern="1200" dirty="0" smtClean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igures  S1. </a:t>
            </a:r>
            <a:r>
              <a:rPr lang="en-US" sz="1100" kern="1200" dirty="0" smtClean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Non-invasive 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echocardiography was performed </a:t>
            </a:r>
            <a:r>
              <a:rPr lang="en-US" sz="1100" kern="1200" dirty="0" smtClean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to obtain cardiac anatomical changes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in age-matched </a:t>
            </a:r>
            <a:r>
              <a:rPr lang="en-US" sz="1100" dirty="0" smtClean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(starting age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3 months) 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control </a:t>
            </a:r>
            <a:r>
              <a:rPr lang="en-US" sz="1100" kern="1200" dirty="0" smtClean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(Fischer 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344) and Tg rats </a:t>
            </a:r>
            <a:r>
              <a:rPr lang="en-US" sz="1100" kern="1200" dirty="0" smtClean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laced on Mg normal or Mg supplemented (6 x </a:t>
            </a:r>
            <a:r>
              <a:rPr lang="en-US" sz="1100" dirty="0" smtClean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higher than normal) diets </a:t>
            </a:r>
            <a:r>
              <a:rPr lang="en-US" sz="1100" kern="1200" dirty="0" smtClean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or an additional18 weeks. 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No values for </a:t>
            </a:r>
            <a:r>
              <a:rPr lang="en-US" sz="1100" kern="1200" dirty="0" smtClean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baseline Tg were 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ignificantly different </a:t>
            </a:r>
            <a:r>
              <a:rPr lang="en-US" sz="1100" kern="1200" dirty="0" smtClean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rom baseline </a:t>
            </a:r>
            <a:r>
              <a:rPr lang="en-US" sz="1100" dirty="0" smtClean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control.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VSd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&amp; s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= interventricular septum dimension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mm) in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iastole and systole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; and </a:t>
            </a:r>
            <a:r>
              <a:rPr lang="en-US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VPWd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&amp; s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= left ventricular posterior wall dimension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mm) in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iastole and systole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sz="1100" kern="1200" dirty="0" smtClean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Values are means ± SE of 5 rats/group.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610970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508759" y="2166943"/>
            <a:ext cx="90193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eart: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tl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   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tl+cART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g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    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g+cART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    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Kidney:   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tl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  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tl+cART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g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  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g+cART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662545" y="2751513"/>
            <a:ext cx="87117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 13.8±2.1       15.5 ±4.6        35.2±4.2         61.1±4.2                            18.0±4.2        20.7±4.5          36.3±6         44.5±6.6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163782" y="3366656"/>
            <a:ext cx="101747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g-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:            --                 --                 26.4±             27.9±4.5                                   --                --                   28.6±1.2       32.5±5.7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508759" y="1180407"/>
            <a:ext cx="894865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Table S2:  Average % of area of 3-NT staining in the Heart and Kidney of </a:t>
            </a:r>
            <a:r>
              <a:rPr lang="en-US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tl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g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rats ± </a:t>
            </a:r>
            <a:r>
              <a:rPr lang="en-US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ART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in normal control or Mg supplemented diets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868986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5</TotalTime>
  <Words>433</Words>
  <Application>Microsoft Office PowerPoint</Application>
  <PresentationFormat>Widescreen</PresentationFormat>
  <Paragraphs>89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rial</vt:lpstr>
      <vt:lpstr>Calibri</vt:lpstr>
      <vt:lpstr>Calibri Light</vt:lpstr>
      <vt:lpstr>Symbol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>SMHS @ GW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ramer, Jay H</dc:creator>
  <cp:lastModifiedBy>Mak, Iu Tong</cp:lastModifiedBy>
  <cp:revision>12</cp:revision>
  <dcterms:created xsi:type="dcterms:W3CDTF">2018-06-21T16:21:51Z</dcterms:created>
  <dcterms:modified xsi:type="dcterms:W3CDTF">2018-06-28T19:57:10Z</dcterms:modified>
</cp:coreProperties>
</file>